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418"/>
    <p:restoredTop sz="94633"/>
  </p:normalViewPr>
  <p:slideViewPr>
    <p:cSldViewPr snapToGrid="0" snapToObjects="1">
      <p:cViewPr varScale="1">
        <p:scale>
          <a:sx n="77" d="100"/>
          <a:sy n="77" d="100"/>
        </p:scale>
        <p:origin x="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521DD7-9344-AF4C-A07C-4AE32731E0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9D833A-464C-C442-9A60-5FC1EA0BE4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09AD3-504F-4848-A219-B2EF9DBC1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A9280-5ACA-5144-863F-4C6B9697C5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8C91D8-EFA9-514D-B7B3-0BFE0D5E6F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72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DB523-8D26-E946-A931-5A7A8BA8A4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2D6AC3-9E31-E54C-AABE-1F02505685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52688D-BA71-104B-B368-211D26704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9592D0-1FF8-F24D-825D-C6F0B5BAB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D15412-A6C6-A947-B92C-76DBC1081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333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1D2C4F-F40F-AE46-8DF9-33FAA32AC2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0CA460-8B6F-B645-843A-DE3C8D4B66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28980C-14F9-7144-8EA3-6983FEDCA2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8AA3C2-EE38-A34D-BCD5-77E5D85AD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52F8BE-CE0D-B64A-938E-DE930BB77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011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B4D35-C652-E348-852C-5F0F816947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8C51E5-DA4E-E94B-BE4D-78877CEFBE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A7DC49-0DC3-AA4D-A17E-7C3493DF8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4A5ABA-D0ED-B744-B06A-8FB1823C1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A943A0-01E6-3A4B-9958-E188E9DA7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390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2AAA8D-D52E-3847-94C2-FC9B3AF41C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AAF49F-9BC5-E047-B192-AD778F6B73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8055F7-80B3-014C-9967-7082C46EDE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A44D6A-8567-0648-821A-F0D6B3F7E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B94905-365C-5747-9D77-2A551D68C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261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271F57-EE58-4940-8546-D55CD160B6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0B3BC1-B91D-DF4E-BEE2-E5544CE01A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4858F1-52D9-3844-BE1D-628952D7CF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E2EEB7-93DA-AB4B-8089-A4EFA442F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115463-D355-6B45-BE5F-028705BFB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A5D954-1A13-7E49-AB4E-C21F00AE1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227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7FD459-BEF6-9B40-A2CD-15E2DC850F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B2761E-E207-E244-976E-65440E66FB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C223CF-D089-F24B-8A01-541BC59950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822AA0-DA07-0D43-962D-6A22CA6994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6FCE27-2E41-0649-AFE5-B5BE07F3EC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A261D42-5F07-D345-AD80-F565C934B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8E98A7-A4BE-4A43-9C6C-F453CBE96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63BD07-5761-5C4F-A531-F9383F53B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76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54EF87-3DA5-1B4B-9767-BE7DE42856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E310BAA-56A4-DA43-B1F8-AF9784DE6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9E6A27-243A-894A-9F6B-BDD701A63D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716E01-E4B3-F348-8CE6-1C5740BBE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197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F77E93-897D-414B-AF2F-21FBB93B0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6FB9C2-051A-7846-BBD0-F836049AD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F0F3C9-079F-BF48-8415-7B847075F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277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1F8CBB-DAB1-0041-A2A1-CFB2CE1CE5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C5BC94-F420-2347-A3A5-B17C7D13DC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AF6F89-B98A-E74B-8861-8F1975B8D5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324837-F0E4-D042-9861-CBD2DE3018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BFE2F5-2B95-5643-BDE6-8ED7484E8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AB91C8-D7A0-7E4D-955E-DC4B4F62D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115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8810AE-C06A-ED4A-A2B8-09492EA275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031B71-DB7C-C144-8F99-BD4BF6B2F1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CD8E36-42FC-FA4D-A107-B2A89AA95C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CE98B7-36E3-134E-8967-821861C6D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5C26C4-77C0-DC4F-B43C-9E30CFAFA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733CF0-13D9-3F43-9C72-BC1C7D795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280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077B4B-DABB-D34B-8D0C-064FF9D4E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1C14C9-1D6A-F04C-9896-5D85A70BDE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9F7C7B-80AA-7149-A703-5B90C11DD2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DFF8F-04BA-7141-AFB2-AFEF992A6CDA}" type="datetimeFigureOut">
              <a:rPr lang="en-US" smtClean="0"/>
              <a:t>8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507FB6-082C-0F4E-B33D-A61273A07F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926AFF-9387-3D4F-A964-BA36E15F4E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E6609-9234-654F-8385-0F16E3058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586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7AD714F1-03F8-A140-B530-B5422B0A52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3637" y="931333"/>
            <a:ext cx="11359079" cy="504613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2B1ABB6-930F-40F6-AC5A-9E6D34812DEB}"/>
              </a:ext>
            </a:extLst>
          </p:cNvPr>
          <p:cNvSpPr txBox="1"/>
          <p:nvPr/>
        </p:nvSpPr>
        <p:spPr>
          <a:xfrm>
            <a:off x="473637" y="6256599"/>
            <a:ext cx="1168769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dapted from: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ng, LJ, Beeson MS. Milestones in emergency medicine. </a:t>
            </a:r>
            <a:r>
              <a:rPr lang="en-US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 Acute Med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2012;2(3):65-69. </a:t>
            </a:r>
            <a:r>
              <a:rPr lang="en-US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i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10.1016/j.jacme.2012.06.002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25292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ell phone&#10;&#10;Description automatically generated">
            <a:extLst>
              <a:ext uri="{FF2B5EF4-FFF2-40B4-BE49-F238E27FC236}">
                <a16:creationId xmlns:a16="http://schemas.microsoft.com/office/drawing/2014/main" id="{464B47C8-B2B5-494F-8D7D-61D8161075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4636" y="1202267"/>
            <a:ext cx="11322728" cy="44534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10F9B10-27F9-4FD2-8D39-9BA7B7F0E266}"/>
              </a:ext>
            </a:extLst>
          </p:cNvPr>
          <p:cNvSpPr txBox="1"/>
          <p:nvPr/>
        </p:nvSpPr>
        <p:spPr>
          <a:xfrm>
            <a:off x="473637" y="6256599"/>
            <a:ext cx="1168769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dapted from: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ng, LJ, Beeson MS. Milestones in emergency medicine. </a:t>
            </a:r>
            <a:r>
              <a:rPr lang="en-US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 Acute Med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2012;2(3):65-69. </a:t>
            </a:r>
            <a:r>
              <a:rPr lang="en-US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i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10.1016/j.jacme.2012.06.002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67767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ell phone&#10;&#10;Description automatically generated">
            <a:extLst>
              <a:ext uri="{FF2B5EF4-FFF2-40B4-BE49-F238E27FC236}">
                <a16:creationId xmlns:a16="http://schemas.microsoft.com/office/drawing/2014/main" id="{9720E19E-D9A2-5942-9C0C-F3A8DE6DE9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731" y="897467"/>
            <a:ext cx="11135587" cy="494453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F09C624-9A33-4001-A454-F62A88085CDC}"/>
              </a:ext>
            </a:extLst>
          </p:cNvPr>
          <p:cNvSpPr txBox="1"/>
          <p:nvPr/>
        </p:nvSpPr>
        <p:spPr>
          <a:xfrm>
            <a:off x="473637" y="6256599"/>
            <a:ext cx="1168769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dapted from: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ng, LJ, Beeson MS. Milestones in emergency medicine. </a:t>
            </a:r>
            <a:r>
              <a:rPr lang="en-US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 Acute Med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2012;2(3):65-69. </a:t>
            </a:r>
            <a:r>
              <a:rPr lang="en-US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i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10.1016/j.jacme.2012.06.002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02558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ell phone&#10;&#10;Description automatically generated">
            <a:extLst>
              <a:ext uri="{FF2B5EF4-FFF2-40B4-BE49-F238E27FC236}">
                <a16:creationId xmlns:a16="http://schemas.microsoft.com/office/drawing/2014/main" id="{C2092C75-6549-8545-B2AE-49C6929534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959" y="856146"/>
            <a:ext cx="12089041" cy="51457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1B07153-9715-419E-8DD8-BA47AFA299EA}"/>
              </a:ext>
            </a:extLst>
          </p:cNvPr>
          <p:cNvSpPr txBox="1"/>
          <p:nvPr/>
        </p:nvSpPr>
        <p:spPr>
          <a:xfrm>
            <a:off x="473637" y="6256599"/>
            <a:ext cx="1168769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dapted from: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ng, LJ, Beeson MS. Milestones in emergency medicine. </a:t>
            </a:r>
            <a:r>
              <a:rPr lang="en-US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 Acute Med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2012;2(3):65-69. </a:t>
            </a:r>
            <a:r>
              <a:rPr lang="en-US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i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10.1016/j.jacme.2012.06.002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35174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cell phone&#10;&#10;Description automatically generated">
            <a:extLst>
              <a:ext uri="{FF2B5EF4-FFF2-40B4-BE49-F238E27FC236}">
                <a16:creationId xmlns:a16="http://schemas.microsoft.com/office/drawing/2014/main" id="{E19B502E-76E4-EE4A-91FD-AEB7087D87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267" y="225593"/>
            <a:ext cx="11673343" cy="63276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1603D01-6799-492D-93CE-CA5127D6B04F}"/>
              </a:ext>
            </a:extLst>
          </p:cNvPr>
          <p:cNvSpPr txBox="1"/>
          <p:nvPr/>
        </p:nvSpPr>
        <p:spPr>
          <a:xfrm>
            <a:off x="171915" y="6542003"/>
            <a:ext cx="1168769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dapted from: 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ng, LJ, Beeson MS. Milestones in emergency medicine. </a:t>
            </a:r>
            <a:r>
              <a:rPr lang="en-US" sz="14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J Acute Med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2012;2(3):65-69. </a:t>
            </a:r>
            <a:r>
              <a:rPr lang="en-US" sz="14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i</a:t>
            </a:r>
            <a:r>
              <a:rPr lang="en-US" sz="14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10.1016/j.jacme.2012.06.002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9541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65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Abboud</dc:creator>
  <cp:lastModifiedBy>Hannah Turner</cp:lastModifiedBy>
  <cp:revision>2</cp:revision>
  <dcterms:created xsi:type="dcterms:W3CDTF">2020-02-15T23:50:29Z</dcterms:created>
  <dcterms:modified xsi:type="dcterms:W3CDTF">2022-08-08T12:47:03Z</dcterms:modified>
</cp:coreProperties>
</file>